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64" r:id="rId1"/>
  </p:sldMasterIdLst>
  <p:notesMasterIdLst>
    <p:notesMasterId r:id="rId3"/>
  </p:notesMasterIdLst>
  <p:sldIdLst>
    <p:sldId id="263" r:id="rId2"/>
  </p:sldIdLst>
  <p:sldSz cx="3959225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9" userDrawn="1">
          <p15:clr>
            <a:srgbClr val="A4A3A4"/>
          </p15:clr>
        </p15:guide>
        <p15:guide id="2" pos="12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4383"/>
  </p:normalViewPr>
  <p:slideViewPr>
    <p:cSldViewPr snapToGrid="0" showGuides="1">
      <p:cViewPr varScale="1">
        <p:scale>
          <a:sx n="138" d="100"/>
          <a:sy n="138" d="100"/>
        </p:scale>
        <p:origin x="4328" y="176"/>
      </p:cViewPr>
      <p:guideLst>
        <p:guide orient="horz" pos="2609"/>
        <p:guide pos="12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8B3DC4-9CF6-154E-B92E-8F9AD349A80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690813" y="1143000"/>
            <a:ext cx="14763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6AD6B4-BB94-714E-BB11-9D8B3A2B40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212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67749" rtl="0" eaLnBrk="1" latinLnBrk="0" hangingPunct="1">
      <a:defRPr kumimoji="1" sz="482" kern="1200">
        <a:solidFill>
          <a:schemeClr val="tx1"/>
        </a:solidFill>
        <a:latin typeface="+mn-lt"/>
        <a:ea typeface="+mn-ea"/>
        <a:cs typeface="+mn-cs"/>
      </a:defRPr>
    </a:lvl1pPr>
    <a:lvl2pPr marL="183874" algn="l" defTabSz="367749" rtl="0" eaLnBrk="1" latinLnBrk="0" hangingPunct="1">
      <a:defRPr kumimoji="1" sz="482" kern="1200">
        <a:solidFill>
          <a:schemeClr val="tx1"/>
        </a:solidFill>
        <a:latin typeface="+mn-lt"/>
        <a:ea typeface="+mn-ea"/>
        <a:cs typeface="+mn-cs"/>
      </a:defRPr>
    </a:lvl2pPr>
    <a:lvl3pPr marL="367749" algn="l" defTabSz="367749" rtl="0" eaLnBrk="1" latinLnBrk="0" hangingPunct="1">
      <a:defRPr kumimoji="1" sz="482" kern="1200">
        <a:solidFill>
          <a:schemeClr val="tx1"/>
        </a:solidFill>
        <a:latin typeface="+mn-lt"/>
        <a:ea typeface="+mn-ea"/>
        <a:cs typeface="+mn-cs"/>
      </a:defRPr>
    </a:lvl3pPr>
    <a:lvl4pPr marL="551624" algn="l" defTabSz="367749" rtl="0" eaLnBrk="1" latinLnBrk="0" hangingPunct="1">
      <a:defRPr kumimoji="1" sz="482" kern="1200">
        <a:solidFill>
          <a:schemeClr val="tx1"/>
        </a:solidFill>
        <a:latin typeface="+mn-lt"/>
        <a:ea typeface="+mn-ea"/>
        <a:cs typeface="+mn-cs"/>
      </a:defRPr>
    </a:lvl4pPr>
    <a:lvl5pPr marL="735499" algn="l" defTabSz="367749" rtl="0" eaLnBrk="1" latinLnBrk="0" hangingPunct="1">
      <a:defRPr kumimoji="1" sz="482" kern="1200">
        <a:solidFill>
          <a:schemeClr val="tx1"/>
        </a:solidFill>
        <a:latin typeface="+mn-lt"/>
        <a:ea typeface="+mn-ea"/>
        <a:cs typeface="+mn-cs"/>
      </a:defRPr>
    </a:lvl5pPr>
    <a:lvl6pPr marL="919373" algn="l" defTabSz="367749" rtl="0" eaLnBrk="1" latinLnBrk="0" hangingPunct="1">
      <a:defRPr kumimoji="1" sz="482" kern="1200">
        <a:solidFill>
          <a:schemeClr val="tx1"/>
        </a:solidFill>
        <a:latin typeface="+mn-lt"/>
        <a:ea typeface="+mn-ea"/>
        <a:cs typeface="+mn-cs"/>
      </a:defRPr>
    </a:lvl6pPr>
    <a:lvl7pPr marL="1103248" algn="l" defTabSz="367749" rtl="0" eaLnBrk="1" latinLnBrk="0" hangingPunct="1">
      <a:defRPr kumimoji="1" sz="482" kern="1200">
        <a:solidFill>
          <a:schemeClr val="tx1"/>
        </a:solidFill>
        <a:latin typeface="+mn-lt"/>
        <a:ea typeface="+mn-ea"/>
        <a:cs typeface="+mn-cs"/>
      </a:defRPr>
    </a:lvl7pPr>
    <a:lvl8pPr marL="1287122" algn="l" defTabSz="367749" rtl="0" eaLnBrk="1" latinLnBrk="0" hangingPunct="1">
      <a:defRPr kumimoji="1" sz="482" kern="1200">
        <a:solidFill>
          <a:schemeClr val="tx1"/>
        </a:solidFill>
        <a:latin typeface="+mn-lt"/>
        <a:ea typeface="+mn-ea"/>
        <a:cs typeface="+mn-cs"/>
      </a:defRPr>
    </a:lvl8pPr>
    <a:lvl9pPr marL="1470997" algn="l" defTabSz="367749" rtl="0" eaLnBrk="1" latinLnBrk="0" hangingPunct="1">
      <a:defRPr kumimoji="1" sz="48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690813" y="1143000"/>
            <a:ext cx="14763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6AD6B4-BB94-714E-BB11-9D8B3A2B40A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663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96942" y="1355149"/>
            <a:ext cx="3365341" cy="2882806"/>
          </a:xfrm>
        </p:spPr>
        <p:txBody>
          <a:bodyPr anchor="b"/>
          <a:lstStyle>
            <a:lvl1pPr algn="ctr">
              <a:defRPr sz="25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94903" y="4349128"/>
            <a:ext cx="2969419" cy="1999179"/>
          </a:xfrm>
        </p:spPr>
        <p:txBody>
          <a:bodyPr/>
          <a:lstStyle>
            <a:lvl1pPr marL="0" indent="0" algn="ctr">
              <a:buNone/>
              <a:defRPr sz="1039"/>
            </a:lvl1pPr>
            <a:lvl2pPr marL="197968" indent="0" algn="ctr">
              <a:buNone/>
              <a:defRPr sz="866"/>
            </a:lvl2pPr>
            <a:lvl3pPr marL="395935" indent="0" algn="ctr">
              <a:buNone/>
              <a:defRPr sz="779"/>
            </a:lvl3pPr>
            <a:lvl4pPr marL="593903" indent="0" algn="ctr">
              <a:buNone/>
              <a:defRPr sz="693"/>
            </a:lvl4pPr>
            <a:lvl5pPr marL="791870" indent="0" algn="ctr">
              <a:buNone/>
              <a:defRPr sz="693"/>
            </a:lvl5pPr>
            <a:lvl6pPr marL="989838" indent="0" algn="ctr">
              <a:buNone/>
              <a:defRPr sz="693"/>
            </a:lvl6pPr>
            <a:lvl7pPr marL="1187806" indent="0" algn="ctr">
              <a:buNone/>
              <a:defRPr sz="693"/>
            </a:lvl7pPr>
            <a:lvl8pPr marL="1385773" indent="0" algn="ctr">
              <a:buNone/>
              <a:defRPr sz="693"/>
            </a:lvl8pPr>
            <a:lvl9pPr marL="1583741" indent="0" algn="ctr">
              <a:buNone/>
              <a:defRPr sz="69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0598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702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833321" y="440855"/>
            <a:ext cx="853708" cy="70172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72197" y="440855"/>
            <a:ext cx="2511633" cy="70172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460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790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0135" y="2064352"/>
            <a:ext cx="3414832" cy="3444416"/>
          </a:xfrm>
        </p:spPr>
        <p:txBody>
          <a:bodyPr anchor="b"/>
          <a:lstStyle>
            <a:lvl1pPr>
              <a:defRPr sz="25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0135" y="5541353"/>
            <a:ext cx="3414832" cy="1811337"/>
          </a:xfrm>
        </p:spPr>
        <p:txBody>
          <a:bodyPr/>
          <a:lstStyle>
            <a:lvl1pPr marL="0" indent="0">
              <a:buNone/>
              <a:defRPr sz="1039">
                <a:solidFill>
                  <a:schemeClr val="tx1"/>
                </a:solidFill>
              </a:defRPr>
            </a:lvl1pPr>
            <a:lvl2pPr marL="197968" indent="0">
              <a:buNone/>
              <a:defRPr sz="866">
                <a:solidFill>
                  <a:schemeClr val="tx1">
                    <a:tint val="75000"/>
                  </a:schemeClr>
                </a:solidFill>
              </a:defRPr>
            </a:lvl2pPr>
            <a:lvl3pPr marL="395935" indent="0">
              <a:buNone/>
              <a:defRPr sz="779">
                <a:solidFill>
                  <a:schemeClr val="tx1">
                    <a:tint val="75000"/>
                  </a:schemeClr>
                </a:solidFill>
              </a:defRPr>
            </a:lvl3pPr>
            <a:lvl4pPr marL="593903" indent="0">
              <a:buNone/>
              <a:defRPr sz="693">
                <a:solidFill>
                  <a:schemeClr val="tx1">
                    <a:tint val="75000"/>
                  </a:schemeClr>
                </a:solidFill>
              </a:defRPr>
            </a:lvl4pPr>
            <a:lvl5pPr marL="791870" indent="0">
              <a:buNone/>
              <a:defRPr sz="693">
                <a:solidFill>
                  <a:schemeClr val="tx1">
                    <a:tint val="75000"/>
                  </a:schemeClr>
                </a:solidFill>
              </a:defRPr>
            </a:lvl5pPr>
            <a:lvl6pPr marL="989838" indent="0">
              <a:buNone/>
              <a:defRPr sz="693">
                <a:solidFill>
                  <a:schemeClr val="tx1">
                    <a:tint val="75000"/>
                  </a:schemeClr>
                </a:solidFill>
              </a:defRPr>
            </a:lvl6pPr>
            <a:lvl7pPr marL="1187806" indent="0">
              <a:buNone/>
              <a:defRPr sz="693">
                <a:solidFill>
                  <a:schemeClr val="tx1">
                    <a:tint val="75000"/>
                  </a:schemeClr>
                </a:solidFill>
              </a:defRPr>
            </a:lvl7pPr>
            <a:lvl8pPr marL="1385773" indent="0">
              <a:buNone/>
              <a:defRPr sz="693">
                <a:solidFill>
                  <a:schemeClr val="tx1">
                    <a:tint val="75000"/>
                  </a:schemeClr>
                </a:solidFill>
              </a:defRPr>
            </a:lvl8pPr>
            <a:lvl9pPr marL="1583741" indent="0">
              <a:buNone/>
              <a:defRPr sz="69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659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2197" y="2204273"/>
            <a:ext cx="1682671" cy="525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04357" y="2204273"/>
            <a:ext cx="1682671" cy="525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478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2712" y="440856"/>
            <a:ext cx="3414832" cy="1600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2713" y="2029849"/>
            <a:ext cx="1674937" cy="994797"/>
          </a:xfrm>
        </p:spPr>
        <p:txBody>
          <a:bodyPr anchor="b"/>
          <a:lstStyle>
            <a:lvl1pPr marL="0" indent="0">
              <a:buNone/>
              <a:defRPr sz="1039" b="1"/>
            </a:lvl1pPr>
            <a:lvl2pPr marL="197968" indent="0">
              <a:buNone/>
              <a:defRPr sz="866" b="1"/>
            </a:lvl2pPr>
            <a:lvl3pPr marL="395935" indent="0">
              <a:buNone/>
              <a:defRPr sz="779" b="1"/>
            </a:lvl3pPr>
            <a:lvl4pPr marL="593903" indent="0">
              <a:buNone/>
              <a:defRPr sz="693" b="1"/>
            </a:lvl4pPr>
            <a:lvl5pPr marL="791870" indent="0">
              <a:buNone/>
              <a:defRPr sz="693" b="1"/>
            </a:lvl5pPr>
            <a:lvl6pPr marL="989838" indent="0">
              <a:buNone/>
              <a:defRPr sz="693" b="1"/>
            </a:lvl6pPr>
            <a:lvl7pPr marL="1187806" indent="0">
              <a:buNone/>
              <a:defRPr sz="693" b="1"/>
            </a:lvl7pPr>
            <a:lvl8pPr marL="1385773" indent="0">
              <a:buNone/>
              <a:defRPr sz="693" b="1"/>
            </a:lvl8pPr>
            <a:lvl9pPr marL="1583741" indent="0">
              <a:buNone/>
              <a:defRPr sz="69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2713" y="3024646"/>
            <a:ext cx="1674937" cy="44487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004358" y="2029849"/>
            <a:ext cx="1683186" cy="994797"/>
          </a:xfrm>
        </p:spPr>
        <p:txBody>
          <a:bodyPr anchor="b"/>
          <a:lstStyle>
            <a:lvl1pPr marL="0" indent="0">
              <a:buNone/>
              <a:defRPr sz="1039" b="1"/>
            </a:lvl1pPr>
            <a:lvl2pPr marL="197968" indent="0">
              <a:buNone/>
              <a:defRPr sz="866" b="1"/>
            </a:lvl2pPr>
            <a:lvl3pPr marL="395935" indent="0">
              <a:buNone/>
              <a:defRPr sz="779" b="1"/>
            </a:lvl3pPr>
            <a:lvl4pPr marL="593903" indent="0">
              <a:buNone/>
              <a:defRPr sz="693" b="1"/>
            </a:lvl4pPr>
            <a:lvl5pPr marL="791870" indent="0">
              <a:buNone/>
              <a:defRPr sz="693" b="1"/>
            </a:lvl5pPr>
            <a:lvl6pPr marL="989838" indent="0">
              <a:buNone/>
              <a:defRPr sz="693" b="1"/>
            </a:lvl6pPr>
            <a:lvl7pPr marL="1187806" indent="0">
              <a:buNone/>
              <a:defRPr sz="693" b="1"/>
            </a:lvl7pPr>
            <a:lvl8pPr marL="1385773" indent="0">
              <a:buNone/>
              <a:defRPr sz="693" b="1"/>
            </a:lvl8pPr>
            <a:lvl9pPr marL="1583741" indent="0">
              <a:buNone/>
              <a:defRPr sz="69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004358" y="3024646"/>
            <a:ext cx="1683186" cy="44487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8152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6160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2724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2712" y="552027"/>
            <a:ext cx="1276953" cy="1932093"/>
          </a:xfrm>
        </p:spPr>
        <p:txBody>
          <a:bodyPr anchor="b"/>
          <a:lstStyle>
            <a:lvl1pPr>
              <a:defRPr sz="138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83186" y="1192226"/>
            <a:ext cx="2004358" cy="5884451"/>
          </a:xfrm>
        </p:spPr>
        <p:txBody>
          <a:bodyPr/>
          <a:lstStyle>
            <a:lvl1pPr>
              <a:defRPr sz="1386"/>
            </a:lvl1pPr>
            <a:lvl2pPr>
              <a:defRPr sz="1212"/>
            </a:lvl2pPr>
            <a:lvl3pPr>
              <a:defRPr sz="1039"/>
            </a:lvl3pPr>
            <a:lvl4pPr>
              <a:defRPr sz="866"/>
            </a:lvl4pPr>
            <a:lvl5pPr>
              <a:defRPr sz="866"/>
            </a:lvl5pPr>
            <a:lvl6pPr>
              <a:defRPr sz="866"/>
            </a:lvl6pPr>
            <a:lvl7pPr>
              <a:defRPr sz="866"/>
            </a:lvl7pPr>
            <a:lvl8pPr>
              <a:defRPr sz="866"/>
            </a:lvl8pPr>
            <a:lvl9pPr>
              <a:defRPr sz="86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2712" y="2484120"/>
            <a:ext cx="1276953" cy="4602140"/>
          </a:xfrm>
        </p:spPr>
        <p:txBody>
          <a:bodyPr/>
          <a:lstStyle>
            <a:lvl1pPr marL="0" indent="0">
              <a:buNone/>
              <a:defRPr sz="693"/>
            </a:lvl1pPr>
            <a:lvl2pPr marL="197968" indent="0">
              <a:buNone/>
              <a:defRPr sz="606"/>
            </a:lvl2pPr>
            <a:lvl3pPr marL="395935" indent="0">
              <a:buNone/>
              <a:defRPr sz="520"/>
            </a:lvl3pPr>
            <a:lvl4pPr marL="593903" indent="0">
              <a:buNone/>
              <a:defRPr sz="433"/>
            </a:lvl4pPr>
            <a:lvl5pPr marL="791870" indent="0">
              <a:buNone/>
              <a:defRPr sz="433"/>
            </a:lvl5pPr>
            <a:lvl6pPr marL="989838" indent="0">
              <a:buNone/>
              <a:defRPr sz="433"/>
            </a:lvl6pPr>
            <a:lvl7pPr marL="1187806" indent="0">
              <a:buNone/>
              <a:defRPr sz="433"/>
            </a:lvl7pPr>
            <a:lvl8pPr marL="1385773" indent="0">
              <a:buNone/>
              <a:defRPr sz="433"/>
            </a:lvl8pPr>
            <a:lvl9pPr marL="1583741" indent="0">
              <a:buNone/>
              <a:defRPr sz="4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8638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2712" y="552027"/>
            <a:ext cx="1276953" cy="1932093"/>
          </a:xfrm>
        </p:spPr>
        <p:txBody>
          <a:bodyPr anchor="b"/>
          <a:lstStyle>
            <a:lvl1pPr>
              <a:defRPr sz="138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683186" y="1192226"/>
            <a:ext cx="2004358" cy="5884451"/>
          </a:xfrm>
        </p:spPr>
        <p:txBody>
          <a:bodyPr anchor="t"/>
          <a:lstStyle>
            <a:lvl1pPr marL="0" indent="0">
              <a:buNone/>
              <a:defRPr sz="1386"/>
            </a:lvl1pPr>
            <a:lvl2pPr marL="197968" indent="0">
              <a:buNone/>
              <a:defRPr sz="1212"/>
            </a:lvl2pPr>
            <a:lvl3pPr marL="395935" indent="0">
              <a:buNone/>
              <a:defRPr sz="1039"/>
            </a:lvl3pPr>
            <a:lvl4pPr marL="593903" indent="0">
              <a:buNone/>
              <a:defRPr sz="866"/>
            </a:lvl4pPr>
            <a:lvl5pPr marL="791870" indent="0">
              <a:buNone/>
              <a:defRPr sz="866"/>
            </a:lvl5pPr>
            <a:lvl6pPr marL="989838" indent="0">
              <a:buNone/>
              <a:defRPr sz="866"/>
            </a:lvl6pPr>
            <a:lvl7pPr marL="1187806" indent="0">
              <a:buNone/>
              <a:defRPr sz="866"/>
            </a:lvl7pPr>
            <a:lvl8pPr marL="1385773" indent="0">
              <a:buNone/>
              <a:defRPr sz="866"/>
            </a:lvl8pPr>
            <a:lvl9pPr marL="1583741" indent="0">
              <a:buNone/>
              <a:defRPr sz="86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2712" y="2484120"/>
            <a:ext cx="1276953" cy="4602140"/>
          </a:xfrm>
        </p:spPr>
        <p:txBody>
          <a:bodyPr/>
          <a:lstStyle>
            <a:lvl1pPr marL="0" indent="0">
              <a:buNone/>
              <a:defRPr sz="693"/>
            </a:lvl1pPr>
            <a:lvl2pPr marL="197968" indent="0">
              <a:buNone/>
              <a:defRPr sz="606"/>
            </a:lvl2pPr>
            <a:lvl3pPr marL="395935" indent="0">
              <a:buNone/>
              <a:defRPr sz="520"/>
            </a:lvl3pPr>
            <a:lvl4pPr marL="593903" indent="0">
              <a:buNone/>
              <a:defRPr sz="433"/>
            </a:lvl4pPr>
            <a:lvl5pPr marL="791870" indent="0">
              <a:buNone/>
              <a:defRPr sz="433"/>
            </a:lvl5pPr>
            <a:lvl6pPr marL="989838" indent="0">
              <a:buNone/>
              <a:defRPr sz="433"/>
            </a:lvl6pPr>
            <a:lvl7pPr marL="1187806" indent="0">
              <a:buNone/>
              <a:defRPr sz="433"/>
            </a:lvl7pPr>
            <a:lvl8pPr marL="1385773" indent="0">
              <a:buNone/>
              <a:defRPr sz="433"/>
            </a:lvl8pPr>
            <a:lvl9pPr marL="1583741" indent="0">
              <a:buNone/>
              <a:defRPr sz="4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987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2197" y="440856"/>
            <a:ext cx="3414832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2197" y="2204273"/>
            <a:ext cx="3414832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2197" y="7674706"/>
            <a:ext cx="890826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BA1566-B2AB-954F-986E-F27DA3D5F79C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311494" y="7674706"/>
            <a:ext cx="133623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796202" y="7674706"/>
            <a:ext cx="890826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8888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5" r:id="rId1"/>
    <p:sldLayoutId id="2147483866" r:id="rId2"/>
    <p:sldLayoutId id="2147483867" r:id="rId3"/>
    <p:sldLayoutId id="2147483868" r:id="rId4"/>
    <p:sldLayoutId id="2147483869" r:id="rId5"/>
    <p:sldLayoutId id="2147483870" r:id="rId6"/>
    <p:sldLayoutId id="2147483871" r:id="rId7"/>
    <p:sldLayoutId id="2147483872" r:id="rId8"/>
    <p:sldLayoutId id="2147483873" r:id="rId9"/>
    <p:sldLayoutId id="2147483874" r:id="rId10"/>
    <p:sldLayoutId id="2147483875" r:id="rId11"/>
  </p:sldLayoutIdLst>
  <p:txStyles>
    <p:titleStyle>
      <a:lvl1pPr algn="l" defTabSz="395935" rtl="0" eaLnBrk="1" latinLnBrk="0" hangingPunct="1">
        <a:lnSpc>
          <a:spcPct val="90000"/>
        </a:lnSpc>
        <a:spcBef>
          <a:spcPct val="0"/>
        </a:spcBef>
        <a:buNone/>
        <a:defRPr kumimoji="1" sz="19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8984" indent="-98984" algn="l" defTabSz="395935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kumimoji="1" sz="1212" kern="1200">
          <a:solidFill>
            <a:schemeClr val="tx1"/>
          </a:solidFill>
          <a:latin typeface="+mn-lt"/>
          <a:ea typeface="+mn-ea"/>
          <a:cs typeface="+mn-cs"/>
        </a:defRPr>
      </a:lvl1pPr>
      <a:lvl2pPr marL="296951" indent="-98984" algn="l" defTabSz="395935" rtl="0" eaLnBrk="1" latinLnBrk="0" hangingPunct="1">
        <a:lnSpc>
          <a:spcPct val="90000"/>
        </a:lnSpc>
        <a:spcBef>
          <a:spcPts val="217"/>
        </a:spcBef>
        <a:buFont typeface="Arial" panose="020B0604020202020204" pitchFamily="34" charset="0"/>
        <a:buChar char="•"/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2pPr>
      <a:lvl3pPr marL="494919" indent="-98984" algn="l" defTabSz="395935" rtl="0" eaLnBrk="1" latinLnBrk="0" hangingPunct="1">
        <a:lnSpc>
          <a:spcPct val="90000"/>
        </a:lnSpc>
        <a:spcBef>
          <a:spcPts val="217"/>
        </a:spcBef>
        <a:buFont typeface="Arial" panose="020B0604020202020204" pitchFamily="34" charset="0"/>
        <a:buChar char="•"/>
        <a:defRPr kumimoji="1" sz="866" kern="1200">
          <a:solidFill>
            <a:schemeClr val="tx1"/>
          </a:solidFill>
          <a:latin typeface="+mn-lt"/>
          <a:ea typeface="+mn-ea"/>
          <a:cs typeface="+mn-cs"/>
        </a:defRPr>
      </a:lvl3pPr>
      <a:lvl4pPr marL="692887" indent="-98984" algn="l" defTabSz="395935" rtl="0" eaLnBrk="1" latinLnBrk="0" hangingPunct="1">
        <a:lnSpc>
          <a:spcPct val="90000"/>
        </a:lnSpc>
        <a:spcBef>
          <a:spcPts val="217"/>
        </a:spcBef>
        <a:buFont typeface="Arial" panose="020B0604020202020204" pitchFamily="34" charset="0"/>
        <a:buChar char="•"/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4pPr>
      <a:lvl5pPr marL="890854" indent="-98984" algn="l" defTabSz="395935" rtl="0" eaLnBrk="1" latinLnBrk="0" hangingPunct="1">
        <a:lnSpc>
          <a:spcPct val="90000"/>
        </a:lnSpc>
        <a:spcBef>
          <a:spcPts val="217"/>
        </a:spcBef>
        <a:buFont typeface="Arial" panose="020B0604020202020204" pitchFamily="34" charset="0"/>
        <a:buChar char="•"/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5pPr>
      <a:lvl6pPr marL="1088822" indent="-98984" algn="l" defTabSz="395935" rtl="0" eaLnBrk="1" latinLnBrk="0" hangingPunct="1">
        <a:lnSpc>
          <a:spcPct val="90000"/>
        </a:lnSpc>
        <a:spcBef>
          <a:spcPts val="217"/>
        </a:spcBef>
        <a:buFont typeface="Arial" panose="020B0604020202020204" pitchFamily="34" charset="0"/>
        <a:buChar char="•"/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6pPr>
      <a:lvl7pPr marL="1286789" indent="-98984" algn="l" defTabSz="395935" rtl="0" eaLnBrk="1" latinLnBrk="0" hangingPunct="1">
        <a:lnSpc>
          <a:spcPct val="90000"/>
        </a:lnSpc>
        <a:spcBef>
          <a:spcPts val="217"/>
        </a:spcBef>
        <a:buFont typeface="Arial" panose="020B0604020202020204" pitchFamily="34" charset="0"/>
        <a:buChar char="•"/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7pPr>
      <a:lvl8pPr marL="1484757" indent="-98984" algn="l" defTabSz="395935" rtl="0" eaLnBrk="1" latinLnBrk="0" hangingPunct="1">
        <a:lnSpc>
          <a:spcPct val="90000"/>
        </a:lnSpc>
        <a:spcBef>
          <a:spcPts val="217"/>
        </a:spcBef>
        <a:buFont typeface="Arial" panose="020B0604020202020204" pitchFamily="34" charset="0"/>
        <a:buChar char="•"/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8pPr>
      <a:lvl9pPr marL="1682725" indent="-98984" algn="l" defTabSz="395935" rtl="0" eaLnBrk="1" latinLnBrk="0" hangingPunct="1">
        <a:lnSpc>
          <a:spcPct val="90000"/>
        </a:lnSpc>
        <a:spcBef>
          <a:spcPts val="217"/>
        </a:spcBef>
        <a:buFont typeface="Arial" panose="020B0604020202020204" pitchFamily="34" charset="0"/>
        <a:buChar char="•"/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95935" rtl="0" eaLnBrk="1" latinLnBrk="0" hangingPunct="1"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1pPr>
      <a:lvl2pPr marL="197968" algn="l" defTabSz="395935" rtl="0" eaLnBrk="1" latinLnBrk="0" hangingPunct="1"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2pPr>
      <a:lvl3pPr marL="395935" algn="l" defTabSz="395935" rtl="0" eaLnBrk="1" latinLnBrk="0" hangingPunct="1"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3pPr>
      <a:lvl4pPr marL="593903" algn="l" defTabSz="395935" rtl="0" eaLnBrk="1" latinLnBrk="0" hangingPunct="1"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4pPr>
      <a:lvl5pPr marL="791870" algn="l" defTabSz="395935" rtl="0" eaLnBrk="1" latinLnBrk="0" hangingPunct="1"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5pPr>
      <a:lvl6pPr marL="989838" algn="l" defTabSz="395935" rtl="0" eaLnBrk="1" latinLnBrk="0" hangingPunct="1"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6pPr>
      <a:lvl7pPr marL="1187806" algn="l" defTabSz="395935" rtl="0" eaLnBrk="1" latinLnBrk="0" hangingPunct="1"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7pPr>
      <a:lvl8pPr marL="1385773" algn="l" defTabSz="395935" rtl="0" eaLnBrk="1" latinLnBrk="0" hangingPunct="1"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8pPr>
      <a:lvl9pPr marL="1583741" algn="l" defTabSz="395935" rtl="0" eaLnBrk="1" latinLnBrk="0" hangingPunct="1">
        <a:defRPr kumimoji="1" sz="77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285E9BC4-22D4-50BD-9F8F-9A789253929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53123"/>
          <a:stretch/>
        </p:blipFill>
        <p:spPr>
          <a:xfrm>
            <a:off x="299055" y="72883"/>
            <a:ext cx="1855960" cy="3959225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CC2943D7-72B7-46C7-269D-EAC1D013B2E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44889"/>
          <a:stretch/>
        </p:blipFill>
        <p:spPr>
          <a:xfrm>
            <a:off x="2059446" y="72883"/>
            <a:ext cx="2181969" cy="395922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FF20D60-82E8-A998-634D-60CE7E3B9968}"/>
              </a:ext>
            </a:extLst>
          </p:cNvPr>
          <p:cNvSpPr txBox="1"/>
          <p:nvPr/>
        </p:nvSpPr>
        <p:spPr>
          <a:xfrm>
            <a:off x="-2957" y="7512133"/>
            <a:ext cx="3962182" cy="846386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marR="0" algn="l" rtl="0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 S3. </a:t>
            </a:r>
            <a:r>
              <a:rPr lang="en-US" altLang="ja-JP" sz="1200" i="0" u="none" strike="noStrike" kern="100" baseline="0" dirty="0">
                <a:solidFill>
                  <a:srgbClr val="000000"/>
                </a:solidFill>
                <a:latin typeface="Symbol" pitchFamily="2" charset="2"/>
                <a:ea typeface="ＭＳ 明朝" panose="02020609040205080304" pitchFamily="49" charset="-128"/>
              </a:rPr>
              <a:t>d</a:t>
            </a:r>
            <a:r>
              <a:rPr lang="en-US" altLang="ja-JP" sz="1200" i="0" u="none" strike="noStrike" kern="100" baseline="0" dirty="0">
                <a:solidFill>
                  <a:srgbClr val="000000"/>
                </a:solidFill>
                <a:latin typeface="Times" pitchFamily="2" charset="0"/>
                <a:ea typeface="ＭＳ 明朝" panose="02020609040205080304" pitchFamily="49" charset="-128"/>
              </a:rPr>
              <a:t> </a:t>
            </a:r>
            <a:r>
              <a:rPr lang="en-US" altLang="ja-JP" sz="1200" i="0" u="none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lots for lymphoid and myeloid lineages</a:t>
            </a:r>
          </a:p>
          <a:p>
            <a:pPr marR="0" algn="l" rtl="0">
              <a:spcBef>
                <a:spcPts val="600"/>
              </a:spcBef>
            </a:pPr>
            <a:r>
              <a:rPr lang="en-US" altLang="ja-JP" sz="1000" i="0" u="none" strike="noStrike" kern="100" baseline="0" dirty="0" err="1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Treelikeness</a:t>
            </a:r>
            <a:r>
              <a:rPr lang="en-US" altLang="ja-JP" sz="1000" i="0" u="none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was assessed based on all (205,019) sites (A) and all sites without OTHER (102,521) sites (B).</a:t>
            </a:r>
          </a:p>
          <a:p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A7EB119A-57FD-E4DE-10BF-45A5568AB658}"/>
              </a:ext>
            </a:extLst>
          </p:cNvPr>
          <p:cNvSpPr txBox="1"/>
          <p:nvPr/>
        </p:nvSpPr>
        <p:spPr>
          <a:xfrm>
            <a:off x="556002" y="84661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A) all sites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7B84E1FF-143E-DEE7-DD11-75E34F20D8F8}"/>
              </a:ext>
            </a:extLst>
          </p:cNvPr>
          <p:cNvSpPr txBox="1"/>
          <p:nvPr/>
        </p:nvSpPr>
        <p:spPr>
          <a:xfrm>
            <a:off x="1997243" y="84661"/>
            <a:ext cx="18598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B) without OTHER sites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CD576671-6656-1437-6350-603E150A8F05}"/>
              </a:ext>
            </a:extLst>
          </p:cNvPr>
          <p:cNvSpPr txBox="1"/>
          <p:nvPr/>
        </p:nvSpPr>
        <p:spPr>
          <a:xfrm rot="16200000">
            <a:off x="-452044" y="1906188"/>
            <a:ext cx="1378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ymphoid lineage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1EA3E0CB-1B57-0592-B3BE-C70714AF5D1C}"/>
              </a:ext>
            </a:extLst>
          </p:cNvPr>
          <p:cNvSpPr txBox="1"/>
          <p:nvPr/>
        </p:nvSpPr>
        <p:spPr>
          <a:xfrm rot="16200000">
            <a:off x="-386770" y="5338924"/>
            <a:ext cx="1247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yeloid lineage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F209BF91-367A-0590-426C-7B0F82E8FC3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53123"/>
          <a:stretch/>
        </p:blipFill>
        <p:spPr>
          <a:xfrm>
            <a:off x="299060" y="3597539"/>
            <a:ext cx="1855961" cy="3959225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02723B79-119B-95F5-AC78-CF47343A731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54336"/>
          <a:stretch/>
        </p:blipFill>
        <p:spPr>
          <a:xfrm>
            <a:off x="2059449" y="3597539"/>
            <a:ext cx="1807945" cy="3959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1948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37</TotalTime>
  <Words>52</Words>
  <Application>Microsoft Macintosh PowerPoint</Application>
  <PresentationFormat>ユーザー設定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Symbol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柳　香奈子</dc:creator>
  <cp:lastModifiedBy>kkoyanag</cp:lastModifiedBy>
  <cp:revision>105</cp:revision>
  <dcterms:created xsi:type="dcterms:W3CDTF">2022-10-21T02:02:22Z</dcterms:created>
  <dcterms:modified xsi:type="dcterms:W3CDTF">2023-07-27T07:23:59Z</dcterms:modified>
</cp:coreProperties>
</file>